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1271" r:id="rId2"/>
    <p:sldId id="258" r:id="rId3"/>
    <p:sldId id="1273" r:id="rId4"/>
    <p:sldId id="1292" r:id="rId5"/>
    <p:sldId id="1269" r:id="rId6"/>
    <p:sldId id="1275" r:id="rId7"/>
    <p:sldId id="1290" r:id="rId8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941751"/>
    <a:srgbClr val="00539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58"/>
  </p:normalViewPr>
  <p:slideViewPr>
    <p:cSldViewPr snapToGrid="0">
      <p:cViewPr varScale="1">
        <p:scale>
          <a:sx n="120" d="100"/>
          <a:sy n="120" d="100"/>
        </p:scale>
        <p:origin x="80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200" d="100"/>
        <a:sy n="2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microsoft.com/office/2016/11/relationships/changesInfo" Target="changesInfos/changesInfo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Arber, Charlie" userId="a4408506-200b-48fd-8fce-b836ccf79d22" providerId="ADAL" clId="{5627A935-95AC-D747-B0FB-945948A9996B}"/>
    <pc:docChg chg="undo custSel modSld">
      <pc:chgData name="Arber, Charlie" userId="a4408506-200b-48fd-8fce-b836ccf79d22" providerId="ADAL" clId="{5627A935-95AC-D747-B0FB-945948A9996B}" dt="2024-11-22T10:24:03.461" v="68" actId="14100"/>
      <pc:docMkLst>
        <pc:docMk/>
      </pc:docMkLst>
      <pc:sldChg chg="modSp mod">
        <pc:chgData name="Arber, Charlie" userId="a4408506-200b-48fd-8fce-b836ccf79d22" providerId="ADAL" clId="{5627A935-95AC-D747-B0FB-945948A9996B}" dt="2024-11-22T10:23:03.540" v="42" actId="20577"/>
        <pc:sldMkLst>
          <pc:docMk/>
          <pc:sldMk cId="593047412" sldId="1269"/>
        </pc:sldMkLst>
        <pc:spChg chg="mod">
          <ac:chgData name="Arber, Charlie" userId="a4408506-200b-48fd-8fce-b836ccf79d22" providerId="ADAL" clId="{5627A935-95AC-D747-B0FB-945948A9996B}" dt="2024-11-22T10:23:03.540" v="42" actId="20577"/>
          <ac:spMkLst>
            <pc:docMk/>
            <pc:sldMk cId="593047412" sldId="1269"/>
            <ac:spMk id="3" creationId="{2C59CE73-988B-AE9F-3790-E98BD8E5AEF7}"/>
          </ac:spMkLst>
        </pc:spChg>
      </pc:sldChg>
      <pc:sldChg chg="addSp delSp modSp mod">
        <pc:chgData name="Arber, Charlie" userId="a4408506-200b-48fd-8fce-b836ccf79d22" providerId="ADAL" clId="{5627A935-95AC-D747-B0FB-945948A9996B}" dt="2024-11-22T10:23:14.712" v="43" actId="1076"/>
        <pc:sldMkLst>
          <pc:docMk/>
          <pc:sldMk cId="1130055054" sldId="1275"/>
        </pc:sldMkLst>
        <pc:spChg chg="del">
          <ac:chgData name="Arber, Charlie" userId="a4408506-200b-48fd-8fce-b836ccf79d22" providerId="ADAL" clId="{5627A935-95AC-D747-B0FB-945948A9996B}" dt="2024-11-22T10:22:41.548" v="0" actId="478"/>
          <ac:spMkLst>
            <pc:docMk/>
            <pc:sldMk cId="1130055054" sldId="1275"/>
            <ac:spMk id="3" creationId="{0BAA66ED-1A4C-7F95-F050-712F1494EE8C}"/>
          </ac:spMkLst>
        </pc:spChg>
        <pc:spChg chg="mod">
          <ac:chgData name="Arber, Charlie" userId="a4408506-200b-48fd-8fce-b836ccf79d22" providerId="ADAL" clId="{5627A935-95AC-D747-B0FB-945948A9996B}" dt="2024-11-22T10:22:56.066" v="22" actId="20577"/>
          <ac:spMkLst>
            <pc:docMk/>
            <pc:sldMk cId="1130055054" sldId="1275"/>
            <ac:spMk id="4" creationId="{DCD40CD6-38BF-80D6-1F8F-265C9D1ED254}"/>
          </ac:spMkLst>
        </pc:spChg>
        <pc:spChg chg="add del mod">
          <ac:chgData name="Arber, Charlie" userId="a4408506-200b-48fd-8fce-b836ccf79d22" providerId="ADAL" clId="{5627A935-95AC-D747-B0FB-945948A9996B}" dt="2024-11-22T10:22:43.531" v="1" actId="478"/>
          <ac:spMkLst>
            <pc:docMk/>
            <pc:sldMk cId="1130055054" sldId="1275"/>
            <ac:spMk id="5" creationId="{ECE8DFDB-2942-2034-5D93-300845ABB51C}"/>
          </ac:spMkLst>
        </pc:spChg>
        <pc:spChg chg="mod">
          <ac:chgData name="Arber, Charlie" userId="a4408506-200b-48fd-8fce-b836ccf79d22" providerId="ADAL" clId="{5627A935-95AC-D747-B0FB-945948A9996B}" dt="2024-11-22T10:23:14.712" v="43" actId="1076"/>
          <ac:spMkLst>
            <pc:docMk/>
            <pc:sldMk cId="1130055054" sldId="1275"/>
            <ac:spMk id="14" creationId="{C52FFF07-8BDD-0292-F1E7-DEE68B085600}"/>
          </ac:spMkLst>
        </pc:spChg>
        <pc:picChg chg="mod">
          <ac:chgData name="Arber, Charlie" userId="a4408506-200b-48fd-8fce-b836ccf79d22" providerId="ADAL" clId="{5627A935-95AC-D747-B0FB-945948A9996B}" dt="2024-11-22T10:23:14.712" v="43" actId="1076"/>
          <ac:picMkLst>
            <pc:docMk/>
            <pc:sldMk cId="1130055054" sldId="1275"/>
            <ac:picMk id="12" creationId="{EBE9B07E-885E-B663-27DD-35868BF09F7B}"/>
          </ac:picMkLst>
        </pc:picChg>
        <pc:picChg chg="mod">
          <ac:chgData name="Arber, Charlie" userId="a4408506-200b-48fd-8fce-b836ccf79d22" providerId="ADAL" clId="{5627A935-95AC-D747-B0FB-945948A9996B}" dt="2024-11-22T10:23:14.712" v="43" actId="1076"/>
          <ac:picMkLst>
            <pc:docMk/>
            <pc:sldMk cId="1130055054" sldId="1275"/>
            <ac:picMk id="13" creationId="{26DE6506-E360-6164-3740-E5E76DB55305}"/>
          </ac:picMkLst>
        </pc:picChg>
      </pc:sldChg>
      <pc:sldChg chg="addSp delSp modSp mod">
        <pc:chgData name="Arber, Charlie" userId="a4408506-200b-48fd-8fce-b836ccf79d22" providerId="ADAL" clId="{5627A935-95AC-D747-B0FB-945948A9996B}" dt="2024-11-22T10:24:03.461" v="68" actId="14100"/>
        <pc:sldMkLst>
          <pc:docMk/>
          <pc:sldMk cId="972533143" sldId="1290"/>
        </pc:sldMkLst>
        <pc:spChg chg="del">
          <ac:chgData name="Arber, Charlie" userId="a4408506-200b-48fd-8fce-b836ccf79d22" providerId="ADAL" clId="{5627A935-95AC-D747-B0FB-945948A9996B}" dt="2024-11-22T10:23:23.361" v="56" actId="478"/>
          <ac:spMkLst>
            <pc:docMk/>
            <pc:sldMk cId="972533143" sldId="1290"/>
            <ac:spMk id="2" creationId="{8BE8A466-4EF0-59AD-F49F-97F058CF37CC}"/>
          </ac:spMkLst>
        </pc:spChg>
        <pc:spChg chg="mod">
          <ac:chgData name="Arber, Charlie" userId="a4408506-200b-48fd-8fce-b836ccf79d22" providerId="ADAL" clId="{5627A935-95AC-D747-B0FB-945948A9996B}" dt="2024-11-22T10:23:21.214" v="55" actId="20577"/>
          <ac:spMkLst>
            <pc:docMk/>
            <pc:sldMk cId="972533143" sldId="1290"/>
            <ac:spMk id="3" creationId="{53537747-6454-C626-8047-E15741001116}"/>
          </ac:spMkLst>
        </pc:spChg>
        <pc:spChg chg="add del mod">
          <ac:chgData name="Arber, Charlie" userId="a4408506-200b-48fd-8fce-b836ccf79d22" providerId="ADAL" clId="{5627A935-95AC-D747-B0FB-945948A9996B}" dt="2024-11-22T10:23:25.472" v="57" actId="478"/>
          <ac:spMkLst>
            <pc:docMk/>
            <pc:sldMk cId="972533143" sldId="1290"/>
            <ac:spMk id="6" creationId="{5C778377-911D-2CD9-FC43-5A718AD0DA84}"/>
          </ac:spMkLst>
        </pc:spChg>
        <pc:spChg chg="add del mod">
          <ac:chgData name="Arber, Charlie" userId="a4408506-200b-48fd-8fce-b836ccf79d22" providerId="ADAL" clId="{5627A935-95AC-D747-B0FB-945948A9996B}" dt="2024-11-22T10:23:47.981" v="61" actId="478"/>
          <ac:spMkLst>
            <pc:docMk/>
            <pc:sldMk cId="972533143" sldId="1290"/>
            <ac:spMk id="8" creationId="{2090E447-CC79-B654-2E4E-B6157A53CB7C}"/>
          </ac:spMkLst>
        </pc:spChg>
        <pc:spChg chg="del mod">
          <ac:chgData name="Arber, Charlie" userId="a4408506-200b-48fd-8fce-b836ccf79d22" providerId="ADAL" clId="{5627A935-95AC-D747-B0FB-945948A9996B}" dt="2024-11-22T10:23:47.981" v="61" actId="478"/>
          <ac:spMkLst>
            <pc:docMk/>
            <pc:sldMk cId="972533143" sldId="1290"/>
            <ac:spMk id="9" creationId="{56954847-0B80-53E1-145B-E7E0EEE588D7}"/>
          </ac:spMkLst>
        </pc:spChg>
        <pc:picChg chg="mod">
          <ac:chgData name="Arber, Charlie" userId="a4408506-200b-48fd-8fce-b836ccf79d22" providerId="ADAL" clId="{5627A935-95AC-D747-B0FB-945948A9996B}" dt="2024-11-22T10:24:03.461" v="68" actId="14100"/>
          <ac:picMkLst>
            <pc:docMk/>
            <pc:sldMk cId="972533143" sldId="1290"/>
            <ac:picMk id="5" creationId="{7EB5DF08-5E07-1D9D-6BD7-0DEB2D7FED31}"/>
          </ac:picMkLst>
        </pc:picChg>
        <pc:picChg chg="mod">
          <ac:chgData name="Arber, Charlie" userId="a4408506-200b-48fd-8fce-b836ccf79d22" providerId="ADAL" clId="{5627A935-95AC-D747-B0FB-945948A9996B}" dt="2024-11-22T10:24:00.059" v="67" actId="208"/>
          <ac:picMkLst>
            <pc:docMk/>
            <pc:sldMk cId="972533143" sldId="1290"/>
            <ac:picMk id="7" creationId="{DE25F114-12C8-13D0-A3DE-E08459D4F5F9}"/>
          </ac:picMkLst>
        </pc:pic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92B5C8F-F103-378E-EBC9-3C5AD15E970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103F5086-6AB4-C236-5652-A4A5245EA6F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9127BC7-087F-A3A1-3C1F-C75E2F83F8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174D-D316-6046-B072-DDC6A675537E}" type="datetimeFigureOut">
              <a:rPr lang="en-GB" smtClean="0"/>
              <a:t>22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B8F56D7-80C3-53F1-FF0A-15D19FA4925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3467287-37FC-C58E-0127-74C35FAB43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F38D2-4C6C-9D47-9C9B-08488B3414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77751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671E52-B578-8EC9-2A10-41C2DEF31AD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5EE31C9-3AE0-47C2-4493-420C3561360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7367FA3-BE1D-75C2-C30A-E989CCAABC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174D-D316-6046-B072-DDC6A675537E}" type="datetimeFigureOut">
              <a:rPr lang="en-GB" smtClean="0"/>
              <a:t>22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673B58-8A5F-38AC-91BD-5843840AC2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B2EE6D9-BCB1-BE3E-A130-829A2B61C9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F38D2-4C6C-9D47-9C9B-08488B3414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909739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4C6CCC6-022C-B704-6271-7054288D900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03233E6-CC19-EF7D-6E4E-9ED1C66F45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F87912-5494-5E0E-04CE-4AAF2E61F2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174D-D316-6046-B072-DDC6A675537E}" type="datetimeFigureOut">
              <a:rPr lang="en-GB" smtClean="0"/>
              <a:t>22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1F4A62F-0313-3184-5852-99AB499C2E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A5DE599-3C20-677A-1062-872DF57FE1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F38D2-4C6C-9D47-9C9B-08488B3414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5477280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UCL single text bloc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Main Headline" descr="Headline">
            <a:extLst>
              <a:ext uri="{FF2B5EF4-FFF2-40B4-BE49-F238E27FC236}">
                <a16:creationId xmlns:a16="http://schemas.microsoft.com/office/drawing/2014/main" id="{D136E2B9-C028-5142-BBB3-807BD19349DB}"/>
              </a:ext>
            </a:extLst>
          </p:cNvPr>
          <p:cNvSpPr>
            <a:spLocks noGrp="1"/>
          </p:cNvSpPr>
          <p:nvPr>
            <p:ph type="title" hasCustomPrompt="1"/>
          </p:nvPr>
        </p:nvSpPr>
        <p:spPr>
          <a:xfrm>
            <a:off x="360000" y="899999"/>
            <a:ext cx="8999900" cy="1368000"/>
          </a:xfrm>
        </p:spPr>
        <p:txBody>
          <a:bodyPr/>
          <a:lstStyle/>
          <a:p>
            <a:r>
              <a:rPr lang="en-US"/>
              <a:t>Main headline, Arial 44pt bold</a:t>
            </a:r>
          </a:p>
        </p:txBody>
      </p:sp>
      <p:sp>
        <p:nvSpPr>
          <p:cNvPr id="12" name="Text" descr="Text">
            <a:extLst>
              <a:ext uri="{FF2B5EF4-FFF2-40B4-BE49-F238E27FC236}">
                <a16:creationId xmlns:a16="http://schemas.microsoft.com/office/drawing/2014/main" id="{52E39625-6121-A140-A00B-27BF9DA232CD}"/>
              </a:ext>
            </a:extLst>
          </p:cNvPr>
          <p:cNvSpPr>
            <a:spLocks noGrp="1"/>
          </p:cNvSpPr>
          <p:nvPr>
            <p:ph type="body" sz="quarter" idx="13"/>
          </p:nvPr>
        </p:nvSpPr>
        <p:spPr>
          <a:xfrm>
            <a:off x="360000" y="2412000"/>
            <a:ext cx="10439064" cy="3600000"/>
          </a:xfrm>
        </p:spPr>
        <p:txBody>
          <a:bodyPr/>
          <a:lstStyle>
            <a:lvl1pPr marL="225425" marR="0" indent="-225425" algn="l" defTabSz="914400" rtl="0" eaLnBrk="1" fontAlgn="base" latinLnBrk="0" hangingPunct="1">
              <a:lnSpc>
                <a:spcPct val="90000"/>
              </a:lnSpc>
              <a:spcBef>
                <a:spcPts val="1000"/>
              </a:spcBef>
              <a:spcAft>
                <a:spcPct val="0"/>
              </a:spcAft>
              <a:buClrTx/>
              <a:buSzTx/>
              <a:buFont typeface="Arial" panose="020B0604020202020204" pitchFamily="34" charset="0"/>
              <a:buChar char="•"/>
              <a:tabLst/>
              <a:defRPr sz="2400"/>
            </a:lvl1pPr>
            <a:lvl2pPr marL="222250" indent="-222250">
              <a:buFont typeface="Arial" panose="020B0604020202020204" pitchFamily="34" charset="0"/>
              <a:buChar char="•"/>
              <a:tabLst/>
              <a:defRPr/>
            </a:lvl2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06E4EAF8-165C-2D4A-9B32-495E40A071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>
              <a:defRPr/>
            </a:pPr>
            <a:fld id="{C6478F44-CA4B-8F47-8400-2C19AC9A20AB}" type="datetimeFigureOut">
              <a:rPr lang="en-US" smtClean="0"/>
              <a:pPr>
                <a:defRPr/>
              </a:pPr>
              <a:t>11/22/24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5EBBB3CA-848C-EF44-BEE5-EB67145F2B7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>
              <a:defRPr/>
            </a:pPr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ADB6E47-510B-8542-8D2A-81F475B8DE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>
              <a:defRPr/>
            </a:pPr>
            <a:fld id="{A68DF897-BF7D-364E-94C4-DBD7D61CD3A9}" type="slidenum">
              <a:rPr lang="en-US" smtClean="0"/>
              <a:pPr>
                <a:defRPr/>
              </a:pPr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44704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0F2307A-A1FE-1283-361E-AE45209E46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28EDD2-11BA-45FC-D2B4-80C14F88B593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2DC461A-A390-0FD9-E62C-BCFF3EA46E9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174D-D316-6046-B072-DDC6A675537E}" type="datetimeFigureOut">
              <a:rPr lang="en-GB" smtClean="0"/>
              <a:t>22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40AA8C0-E486-5F7A-9F4A-BAC74C3A0C2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A03D3EF-79CA-16CA-C96F-C800F7A21A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F38D2-4C6C-9D47-9C9B-08488B3414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50315596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D8A7AD8-4B39-B061-D459-D9F47216D8E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4C05F83-72E1-192B-BD45-63B17773B56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21F7821-1D1F-4B80-1DFE-1A2D9CF868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174D-D316-6046-B072-DDC6A675537E}" type="datetimeFigureOut">
              <a:rPr lang="en-GB" smtClean="0"/>
              <a:t>22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9D77604-B49E-C78D-E7A7-C8EAC46497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C89764A-83F9-38FC-88DA-16E75193D93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F38D2-4C6C-9D47-9C9B-08488B3414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1349691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EF644CA-53C4-EF81-0302-3B07E7A2B3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3CAD3A3-6C84-023A-602E-D35565C4BD3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DCB5916-FFCA-0063-BB2D-FD1455E5B72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2718C94-1316-7212-97BC-FD8B600248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174D-D316-6046-B072-DDC6A675537E}" type="datetimeFigureOut">
              <a:rPr lang="en-GB" smtClean="0"/>
              <a:t>22/1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60F9054-5390-E5E3-EFAE-9667C86AF6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8948A77-1736-D9FE-0E9A-9832A97CA0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F38D2-4C6C-9D47-9C9B-08488B3414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2807469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79F08F6-57E5-6602-534C-8469078F605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2968BF3-C7EB-4BC9-523A-4BCDFA6367F7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6D941D4D-2D3D-FBE7-A232-52E29B06BC4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C7A7B34-3E22-0498-47A4-A9C9C452F0C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6A49C39-0D2A-5B84-17DF-0BA82DF583AD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19CF7CA8-442C-F8EE-7691-C13D0F1ED45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174D-D316-6046-B072-DDC6A675537E}" type="datetimeFigureOut">
              <a:rPr lang="en-GB" smtClean="0"/>
              <a:t>22/11/2024</a:t>
            </a:fld>
            <a:endParaRPr lang="en-GB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25645D9-3397-4227-9A82-947A2A950A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DD73E2B-F125-A830-4BA9-FBF9EF6224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F38D2-4C6C-9D47-9C9B-08488B3414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3952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9CBE83B-F746-67F8-516E-F5A85CBFEA9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A1FCE633-0D04-C6AA-6949-1B5908CC0ED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174D-D316-6046-B072-DDC6A675537E}" type="datetimeFigureOut">
              <a:rPr lang="en-GB" smtClean="0"/>
              <a:t>22/11/2024</a:t>
            </a:fld>
            <a:endParaRPr lang="en-GB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AF08C329-6237-6EDF-0B1D-5A9C2C61AAA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9FD4A04F-7A35-933B-EF81-EB506E80248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F38D2-4C6C-9D47-9C9B-08488B3414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857088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68455463-37D3-AF06-E874-5A55F498965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174D-D316-6046-B072-DDC6A675537E}" type="datetimeFigureOut">
              <a:rPr lang="en-GB" smtClean="0"/>
              <a:t>22/11/2024</a:t>
            </a:fld>
            <a:endParaRPr lang="en-GB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4C2FA7B9-061D-CB61-D08D-64520926151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E897E53-4912-D45C-553D-A1FC5141175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F38D2-4C6C-9D47-9C9B-08488B3414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1870459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D6DFBF-AFC8-CCE3-E8FF-39D2905CBA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3980ED4-7AC4-A302-70C9-487753F0A15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7882857-B904-57A3-31C0-E4FD8B8B5B9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40326DF3-B81B-E1FC-4F8E-F1BFCFA13A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174D-D316-6046-B072-DDC6A675537E}" type="datetimeFigureOut">
              <a:rPr lang="en-GB" smtClean="0"/>
              <a:t>22/1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4127F9-1520-0AC1-2751-23AEB67CA8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04A8521-128F-0BE1-09EB-7B0CFA6C75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F38D2-4C6C-9D47-9C9B-08488B3414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91929062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CC34890-3854-B0B1-4507-9DC5B9BBD4E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11F28355-8747-87D1-935B-EADE819D9A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1AC78612-E38E-B7A4-4F78-02E124547A7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F3074A0-B769-3AD3-E055-5BA10C78322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7FC174D-D316-6046-B072-DDC6A675537E}" type="datetimeFigureOut">
              <a:rPr lang="en-GB" smtClean="0"/>
              <a:t>22/11/2024</a:t>
            </a:fld>
            <a:endParaRPr lang="en-GB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D01BAA-A1D4-F136-C139-1FEDBF9E1A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5DF5566-CF7C-CE68-BF41-364B78325DC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B9F38D2-4C6C-9D47-9C9B-08488B3414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16718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867AA860-7A7A-3E2D-77B2-E20F8CCFF0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9D9B294-4D7E-8BD8-3E48-3A8E1A31F1C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5E7AA63-2A75-1509-3FF8-F26C8ECCA94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FC174D-D316-6046-B072-DDC6A675537E}" type="datetimeFigureOut">
              <a:rPr lang="en-GB" smtClean="0"/>
              <a:t>22/11/2024</a:t>
            </a:fld>
            <a:endParaRPr lang="en-GB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3EA707-46E3-786F-29BE-95B7F518BFEA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F7738C2-8821-2201-A8A0-9E8C7184D1A7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9F38D2-4C6C-9D47-9C9B-08488B341443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6503527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  <p:sldLayoutId id="2147483660" r:id="rId12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png"/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14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16.png"/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18.png"/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 descr="A graph of different colored squares&#10;&#10;Description automatically generated with medium confidence">
            <a:extLst>
              <a:ext uri="{FF2B5EF4-FFF2-40B4-BE49-F238E27FC236}">
                <a16:creationId xmlns:a16="http://schemas.microsoft.com/office/drawing/2014/main" id="{E44FC172-3AE8-D457-83AF-FA7CD0B8B7F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8854" y="3429000"/>
            <a:ext cx="2320829" cy="3247549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88A3F65C-9BA4-D98F-00AF-6B789BBFA8D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4231376" y="693781"/>
            <a:ext cx="6045200" cy="1242547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8" name="Rectangle 7">
            <a:extLst>
              <a:ext uri="{FF2B5EF4-FFF2-40B4-BE49-F238E27FC236}">
                <a16:creationId xmlns:a16="http://schemas.microsoft.com/office/drawing/2014/main" id="{B1A169BD-C885-036B-DB6C-B442B337B6B9}"/>
              </a:ext>
            </a:extLst>
          </p:cNvPr>
          <p:cNvSpPr/>
          <p:nvPr/>
        </p:nvSpPr>
        <p:spPr>
          <a:xfrm>
            <a:off x="6789028" y="564728"/>
            <a:ext cx="231227" cy="1371600"/>
          </a:xfrm>
          <a:prstGeom prst="rect">
            <a:avLst/>
          </a:prstGeom>
          <a:noFill/>
          <a:ln w="9525">
            <a:solidFill>
              <a:srgbClr val="C0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4C863FA7-8C13-5B8A-7C4C-E869C5652782}"/>
              </a:ext>
            </a:extLst>
          </p:cNvPr>
          <p:cNvSpPr txBox="1"/>
          <p:nvPr/>
        </p:nvSpPr>
        <p:spPr>
          <a:xfrm>
            <a:off x="6138268" y="213756"/>
            <a:ext cx="154561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200"/>
              <a:t> Chr14:73659355 A&gt;C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A437D2A5-3F52-48D7-195D-46B5A89784E7}"/>
              </a:ext>
            </a:extLst>
          </p:cNvPr>
          <p:cNvSpPr txBox="1"/>
          <p:nvPr/>
        </p:nvSpPr>
        <p:spPr>
          <a:xfrm>
            <a:off x="108673" y="121423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Figure S1</a:t>
            </a:r>
          </a:p>
        </p:txBody>
      </p:sp>
      <p:pic>
        <p:nvPicPr>
          <p:cNvPr id="4" name="Picture 3" descr="A close up of a cell&#10;&#10;Description automatically generated">
            <a:extLst>
              <a:ext uri="{FF2B5EF4-FFF2-40B4-BE49-F238E27FC236}">
                <a16:creationId xmlns:a16="http://schemas.microsoft.com/office/drawing/2014/main" id="{AE58D506-0F99-7CA4-0770-16A34F4DECD0}"/>
              </a:ext>
            </a:extLst>
          </p:cNvPr>
          <p:cNvPicPr>
            <a:picLocks noChangeAspect="1"/>
          </p:cNvPicPr>
          <p:nvPr/>
        </p:nvPicPr>
        <p:blipFill rotWithShape="1">
          <a:blip r:embed="rId4"/>
          <a:srcRect b="2886"/>
          <a:stretch/>
        </p:blipFill>
        <p:spPr>
          <a:xfrm>
            <a:off x="1468856" y="679067"/>
            <a:ext cx="2320828" cy="225385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96E39B6-8881-A34F-D9C8-98EF1AADAC01}"/>
              </a:ext>
            </a:extLst>
          </p:cNvPr>
          <p:cNvSpPr txBox="1"/>
          <p:nvPr/>
        </p:nvSpPr>
        <p:spPr>
          <a:xfrm>
            <a:off x="1468854" y="270354"/>
            <a:ext cx="2320829" cy="307777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pPr algn="ctr"/>
            <a:r>
              <a:rPr lang="en-GB" sz="1400">
                <a:solidFill>
                  <a:srgbClr val="00B050"/>
                </a:solidFill>
              </a:rPr>
              <a:t>NANOG</a:t>
            </a:r>
            <a:r>
              <a:rPr lang="en-GB" sz="1400"/>
              <a:t> </a:t>
            </a:r>
            <a:r>
              <a:rPr lang="en-GB" sz="1400">
                <a:solidFill>
                  <a:srgbClr val="FF0000"/>
                </a:solidFill>
              </a:rPr>
              <a:t>SSEA4</a:t>
            </a:r>
            <a:r>
              <a:rPr lang="en-GB" sz="1400"/>
              <a:t> </a:t>
            </a:r>
            <a:r>
              <a:rPr lang="en-GB" sz="1400">
                <a:solidFill>
                  <a:schemeClr val="accent1"/>
                </a:solidFill>
              </a:rPr>
              <a:t>DAPI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F3FB9C0E-37A8-073C-34C7-361BA0A134F0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t="6298" b="50000"/>
          <a:stretch/>
        </p:blipFill>
        <p:spPr>
          <a:xfrm>
            <a:off x="4231376" y="3400428"/>
            <a:ext cx="7772400" cy="1727935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FE43BC7A-21B6-40CC-49B0-831C81B21C78}"/>
              </a:ext>
            </a:extLst>
          </p:cNvPr>
          <p:cNvSpPr txBox="1"/>
          <p:nvPr/>
        </p:nvSpPr>
        <p:spPr>
          <a:xfrm>
            <a:off x="1468854" y="213756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063D7CEE-A889-61A7-59F7-263805A1FDBC}"/>
              </a:ext>
            </a:extLst>
          </p:cNvPr>
          <p:cNvSpPr txBox="1"/>
          <p:nvPr/>
        </p:nvSpPr>
        <p:spPr>
          <a:xfrm>
            <a:off x="3913660" y="21375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39C1803-83B3-3CF2-1352-3CAFF325C84F}"/>
              </a:ext>
            </a:extLst>
          </p:cNvPr>
          <p:cNvSpPr txBox="1"/>
          <p:nvPr/>
        </p:nvSpPr>
        <p:spPr>
          <a:xfrm>
            <a:off x="1151138" y="3402872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DE015A5-9025-ED59-3B5E-D1934C27CFFF}"/>
              </a:ext>
            </a:extLst>
          </p:cNvPr>
          <p:cNvSpPr txBox="1"/>
          <p:nvPr/>
        </p:nvSpPr>
        <p:spPr>
          <a:xfrm>
            <a:off x="4241207" y="2981298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202405759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6F3A222-B6DE-D540-03C8-5ABE6C1075F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366658" y="3423991"/>
            <a:ext cx="3378200" cy="3251200"/>
          </a:xfrm>
          <a:prstGeom prst="rect">
            <a:avLst/>
          </a:prstGeom>
        </p:spPr>
      </p:pic>
      <p:sp>
        <p:nvSpPr>
          <p:cNvPr id="5" name="Rounded Rectangle 4">
            <a:extLst>
              <a:ext uri="{FF2B5EF4-FFF2-40B4-BE49-F238E27FC236}">
                <a16:creationId xmlns:a16="http://schemas.microsoft.com/office/drawing/2014/main" id="{9A5F7C9A-CFE1-D4BE-EB00-D355F582A351}"/>
              </a:ext>
            </a:extLst>
          </p:cNvPr>
          <p:cNvSpPr/>
          <p:nvPr/>
        </p:nvSpPr>
        <p:spPr>
          <a:xfrm>
            <a:off x="10177422" y="3741999"/>
            <a:ext cx="219456" cy="134112"/>
          </a:xfrm>
          <a:prstGeom prst="roundRect">
            <a:avLst/>
          </a:prstGeom>
          <a:noFill/>
          <a:ln>
            <a:solidFill>
              <a:srgbClr val="005393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6" name="Rounded Rectangle 5">
            <a:extLst>
              <a:ext uri="{FF2B5EF4-FFF2-40B4-BE49-F238E27FC236}">
                <a16:creationId xmlns:a16="http://schemas.microsoft.com/office/drawing/2014/main" id="{32F87D2E-962D-BD30-507E-C120E611456B}"/>
              </a:ext>
            </a:extLst>
          </p:cNvPr>
          <p:cNvSpPr/>
          <p:nvPr/>
        </p:nvSpPr>
        <p:spPr>
          <a:xfrm>
            <a:off x="10177422" y="3942274"/>
            <a:ext cx="219456" cy="134112"/>
          </a:xfrm>
          <a:prstGeom prst="roundRect">
            <a:avLst/>
          </a:prstGeom>
          <a:noFill/>
          <a:ln>
            <a:solidFill>
              <a:srgbClr val="94175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35B9526-EC86-BB78-FE69-16116CBB5287}"/>
              </a:ext>
            </a:extLst>
          </p:cNvPr>
          <p:cNvSpPr txBox="1"/>
          <p:nvPr/>
        </p:nvSpPr>
        <p:spPr>
          <a:xfrm>
            <a:off x="10459434" y="3622563"/>
            <a:ext cx="114967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Mass spec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7AFE6538-505B-51AC-2552-F8E750C9289E}"/>
              </a:ext>
            </a:extLst>
          </p:cNvPr>
          <p:cNvSpPr txBox="1"/>
          <p:nvPr/>
        </p:nvSpPr>
        <p:spPr>
          <a:xfrm>
            <a:off x="10459434" y="3822838"/>
            <a:ext cx="68954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ELISA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4845D09A-29A7-F372-E422-E26A51308EF4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892133" y="548648"/>
            <a:ext cx="5283200" cy="2819400"/>
          </a:xfrm>
          <a:prstGeom prst="rect">
            <a:avLst/>
          </a:prstGeom>
        </p:spPr>
      </p:pic>
      <p:pic>
        <p:nvPicPr>
          <p:cNvPr id="15" name="Picture 14">
            <a:extLst>
              <a:ext uri="{FF2B5EF4-FFF2-40B4-BE49-F238E27FC236}">
                <a16:creationId xmlns:a16="http://schemas.microsoft.com/office/drawing/2014/main" id="{A91B1440-C762-018F-ECC8-0556330F967B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1714003" y="3419241"/>
            <a:ext cx="3657600" cy="2819400"/>
          </a:xfrm>
          <a:prstGeom prst="rect">
            <a:avLst/>
          </a:prstGeom>
        </p:spPr>
      </p:pic>
      <p:sp>
        <p:nvSpPr>
          <p:cNvPr id="16" name="TextBox 15">
            <a:extLst>
              <a:ext uri="{FF2B5EF4-FFF2-40B4-BE49-F238E27FC236}">
                <a16:creationId xmlns:a16="http://schemas.microsoft.com/office/drawing/2014/main" id="{508DEB89-01A7-CB49-A539-A29ABCAF3C63}"/>
              </a:ext>
            </a:extLst>
          </p:cNvPr>
          <p:cNvSpPr txBox="1"/>
          <p:nvPr/>
        </p:nvSpPr>
        <p:spPr>
          <a:xfrm>
            <a:off x="49609" y="54687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Figure S2</a:t>
            </a:r>
          </a:p>
        </p:txBody>
      </p:sp>
      <p:pic>
        <p:nvPicPr>
          <p:cNvPr id="18" name="Picture 17">
            <a:extLst>
              <a:ext uri="{FF2B5EF4-FFF2-40B4-BE49-F238E27FC236}">
                <a16:creationId xmlns:a16="http://schemas.microsoft.com/office/drawing/2014/main" id="{D169E1FA-6CF2-E267-DFD8-5547D41EC9A6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7293316" y="561348"/>
            <a:ext cx="4483100" cy="2794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3A5A99A-BFED-9734-7F94-FF48246954B3}"/>
              </a:ext>
            </a:extLst>
          </p:cNvPr>
          <p:cNvSpPr txBox="1"/>
          <p:nvPr/>
        </p:nvSpPr>
        <p:spPr>
          <a:xfrm>
            <a:off x="1816218" y="43469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A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682F0B7-8DFA-07A5-2D70-3319376E57EB}"/>
              </a:ext>
            </a:extLst>
          </p:cNvPr>
          <p:cNvSpPr txBox="1"/>
          <p:nvPr/>
        </p:nvSpPr>
        <p:spPr>
          <a:xfrm>
            <a:off x="1816218" y="3228336"/>
            <a:ext cx="30970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E34670DA-A103-8420-FDAA-BDC784A2A8EF}"/>
              </a:ext>
            </a:extLst>
          </p:cNvPr>
          <p:cNvSpPr txBox="1"/>
          <p:nvPr/>
        </p:nvSpPr>
        <p:spPr>
          <a:xfrm>
            <a:off x="7366658" y="434693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C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1ECD0DAB-2DCD-F968-1275-AB77180C793F}"/>
              </a:ext>
            </a:extLst>
          </p:cNvPr>
          <p:cNvSpPr txBox="1"/>
          <p:nvPr/>
        </p:nvSpPr>
        <p:spPr>
          <a:xfrm>
            <a:off x="7366658" y="3228336"/>
            <a:ext cx="32733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D</a:t>
            </a:r>
          </a:p>
        </p:txBody>
      </p:sp>
    </p:spTree>
    <p:extLst>
      <p:ext uri="{BB962C8B-B14F-4D97-AF65-F5344CB8AC3E}">
        <p14:creationId xmlns:p14="http://schemas.microsoft.com/office/powerpoint/2010/main" val="374526527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Content Placeholder 5" descr="A graph of different colored bars&#10;&#10;Description automatically generated">
            <a:extLst>
              <a:ext uri="{FF2B5EF4-FFF2-40B4-BE49-F238E27FC236}">
                <a16:creationId xmlns:a16="http://schemas.microsoft.com/office/drawing/2014/main" id="{6E2CA20E-7E49-2FFE-1859-6E87CF0028F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868864" y="743427"/>
            <a:ext cx="10454272" cy="5371145"/>
          </a:xfr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FC73110C-ED2D-1EA1-D896-DD59D40F7BE5}"/>
              </a:ext>
            </a:extLst>
          </p:cNvPr>
          <p:cNvSpPr txBox="1"/>
          <p:nvPr/>
        </p:nvSpPr>
        <p:spPr>
          <a:xfrm>
            <a:off x="308758" y="213756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Figure S3</a:t>
            </a:r>
          </a:p>
        </p:txBody>
      </p:sp>
    </p:spTree>
    <p:extLst>
      <p:ext uri="{BB962C8B-B14F-4D97-AF65-F5344CB8AC3E}">
        <p14:creationId xmlns:p14="http://schemas.microsoft.com/office/powerpoint/2010/main" val="167665785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TextBox 7">
            <a:extLst>
              <a:ext uri="{FF2B5EF4-FFF2-40B4-BE49-F238E27FC236}">
                <a16:creationId xmlns:a16="http://schemas.microsoft.com/office/drawing/2014/main" id="{5F7B57D8-56B0-04A0-E3C8-0EC0270E114A}"/>
              </a:ext>
            </a:extLst>
          </p:cNvPr>
          <p:cNvSpPr txBox="1"/>
          <p:nvPr/>
        </p:nvSpPr>
        <p:spPr>
          <a:xfrm>
            <a:off x="308758" y="213756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/>
              <a:t>Figure S</a:t>
            </a:r>
            <a:r>
              <a:rPr lang="en-US"/>
              <a:t>4</a:t>
            </a:r>
            <a:endParaRPr lang="en-GB"/>
          </a:p>
        </p:txBody>
      </p:sp>
      <p:pic>
        <p:nvPicPr>
          <p:cNvPr id="6" name="Picture 5" descr="A graph with blue dots&#10;&#10;Description automatically generated">
            <a:extLst>
              <a:ext uri="{FF2B5EF4-FFF2-40B4-BE49-F238E27FC236}">
                <a16:creationId xmlns:a16="http://schemas.microsoft.com/office/drawing/2014/main" id="{59D5BD8E-AE53-78C7-7483-42F6FB18E27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6691" y="1093685"/>
            <a:ext cx="5940938" cy="304724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10" name="Picture 9" descr="A graph with blue dots&#10;&#10;Description automatically generated">
            <a:extLst>
              <a:ext uri="{FF2B5EF4-FFF2-40B4-BE49-F238E27FC236}">
                <a16:creationId xmlns:a16="http://schemas.microsoft.com/office/drawing/2014/main" id="{EF093945-ECC6-C4D4-923A-E79A5D6CDD3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122126" y="1093686"/>
            <a:ext cx="5940938" cy="3047240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</p:spTree>
    <p:extLst>
      <p:ext uri="{BB962C8B-B14F-4D97-AF65-F5344CB8AC3E}">
        <p14:creationId xmlns:p14="http://schemas.microsoft.com/office/powerpoint/2010/main" val="1323375745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Picture 12">
            <a:extLst>
              <a:ext uri="{FF2B5EF4-FFF2-40B4-BE49-F238E27FC236}">
                <a16:creationId xmlns:a16="http://schemas.microsoft.com/office/drawing/2014/main" id="{24E5ECDC-3159-EDF4-6496-B49F9DBB32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28720" y="6097"/>
            <a:ext cx="5492972" cy="343844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AF711FBF-544E-7660-EA92-E05CEC657B3C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228718" y="3444539"/>
            <a:ext cx="5492972" cy="343234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2C59CE73-988B-AE9F-3790-E98BD8E5AEF7}"/>
              </a:ext>
            </a:extLst>
          </p:cNvPr>
          <p:cNvSpPr txBox="1"/>
          <p:nvPr/>
        </p:nvSpPr>
        <p:spPr>
          <a:xfrm>
            <a:off x="308758" y="213756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S</a:t>
            </a:r>
            <a:r>
              <a:rPr lang="en-US" dirty="0"/>
              <a:t>5</a:t>
            </a:r>
            <a:endParaRPr lang="en-GB" dirty="0"/>
          </a:p>
        </p:txBody>
      </p:sp>
      <p:pic>
        <p:nvPicPr>
          <p:cNvPr id="6" name="Picture 5">
            <a:extLst>
              <a:ext uri="{FF2B5EF4-FFF2-40B4-BE49-F238E27FC236}">
                <a16:creationId xmlns:a16="http://schemas.microsoft.com/office/drawing/2014/main" id="{3C50EEBB-E680-597A-7CC8-C692A6320F8C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603028" y="3438442"/>
            <a:ext cx="5492972" cy="34384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9304741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2" name="Picture 11">
            <a:extLst>
              <a:ext uri="{FF2B5EF4-FFF2-40B4-BE49-F238E27FC236}">
                <a16:creationId xmlns:a16="http://schemas.microsoft.com/office/drawing/2014/main" id="{EBE9B07E-885E-B663-27DD-35868BF09F7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17870" y="359401"/>
            <a:ext cx="2167174" cy="6492876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26DE6506-E360-6164-3740-E5E76DB55305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924006" y="359401"/>
            <a:ext cx="2171994" cy="6492875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C52FFF07-8BDD-0292-F1E7-DEE68B085600}"/>
              </a:ext>
            </a:extLst>
          </p:cNvPr>
          <p:cNvSpPr txBox="1"/>
          <p:nvPr/>
        </p:nvSpPr>
        <p:spPr>
          <a:xfrm>
            <a:off x="3025982" y="0"/>
            <a:ext cx="530789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Fitness                     R2                                 PR_AUC</a:t>
            </a:r>
            <a:endParaRPr lang="en-GB" dirty="0"/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CD40CD6-38BF-80D6-1F8F-265C9D1ED254}"/>
              </a:ext>
            </a:extLst>
          </p:cNvPr>
          <p:cNvSpPr txBox="1"/>
          <p:nvPr/>
        </p:nvSpPr>
        <p:spPr>
          <a:xfrm>
            <a:off x="308758" y="213756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S</a:t>
            </a:r>
            <a:r>
              <a:rPr lang="en-US" dirty="0"/>
              <a:t>6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130055054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Content Placeholder 4" descr="A colorfully colored object&#10;&#10;Description automatically generated with low confidence">
            <a:extLst>
              <a:ext uri="{FF2B5EF4-FFF2-40B4-BE49-F238E27FC236}">
                <a16:creationId xmlns:a16="http://schemas.microsoft.com/office/drawing/2014/main" id="{7EB5DF08-5E07-1D9D-6BD7-0DEB2D7FED3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6150903" y="1624721"/>
            <a:ext cx="5862194" cy="4047566"/>
          </a:xfr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pic>
        <p:nvPicPr>
          <p:cNvPr id="7" name="Picture 6" descr="A colorfully colored sphere&#10;&#10;Description automatically generated with low confidence">
            <a:extLst>
              <a:ext uri="{FF2B5EF4-FFF2-40B4-BE49-F238E27FC236}">
                <a16:creationId xmlns:a16="http://schemas.microsoft.com/office/drawing/2014/main" id="{DE25F114-12C8-13D0-A3DE-E08459D4F5F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8904" y="1624721"/>
            <a:ext cx="5862195" cy="4047566"/>
          </a:xfrm>
          <a:prstGeom prst="rect">
            <a:avLst/>
          </a:prstGeom>
          <a:ln>
            <a:solidFill>
              <a:schemeClr val="tx1">
                <a:lumMod val="50000"/>
                <a:lumOff val="50000"/>
              </a:schemeClr>
            </a:solidFill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3537747-6454-C626-8047-E15741001116}"/>
              </a:ext>
            </a:extLst>
          </p:cNvPr>
          <p:cNvSpPr txBox="1"/>
          <p:nvPr/>
        </p:nvSpPr>
        <p:spPr>
          <a:xfrm>
            <a:off x="308758" y="213756"/>
            <a:ext cx="104246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Figure S</a:t>
            </a:r>
            <a:r>
              <a:rPr lang="en-US" dirty="0"/>
              <a:t>7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97253314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Metadata/LabelInfo.xml><?xml version="1.0" encoding="utf-8"?>
<clbl:labelList xmlns:clbl="http://schemas.microsoft.com/office/2020/mipLabelMetadata">
  <clbl:label id="{1faf88fe-a998-4c5b-93c9-210a11d9a5c2}" enabled="0" method="" siteId="{1faf88fe-a998-4c5b-93c9-210a11d9a5c2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otalTime>108</TotalTime>
  <Words>42</Words>
  <Application>Microsoft Macintosh PowerPoint</Application>
  <PresentationFormat>Widescreen</PresentationFormat>
  <Paragraphs>20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1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harlie</dc:creator>
  <cp:lastModifiedBy>Charlie</cp:lastModifiedBy>
  <cp:revision>4</cp:revision>
  <dcterms:created xsi:type="dcterms:W3CDTF">2024-01-26T20:44:41Z</dcterms:created>
  <dcterms:modified xsi:type="dcterms:W3CDTF">2024-11-22T10:24:06Z</dcterms:modified>
</cp:coreProperties>
</file>